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6A68C-12A9-4EDD-98AC-05F37DE959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992F4-9F47-4FFD-883F-07ED1D73B0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0A95C-587B-4B0C-9DA7-85189E5FB5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520" y="176832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520" y="4374000"/>
            <a:ext cx="29199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49004-2A2A-4A01-8BA2-1524FD5EEC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A43C3-595C-4266-B2CD-8E4DE4A312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275F5-61AA-40B9-AFA8-2DEBF16388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C01D9-364C-4354-ADDF-E2FC316472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05111-C8E1-4B4C-BE7A-C10FA8B447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6948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41B5DC-DB75-45F0-B3E1-C40D3E7E94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344DC-77DF-437B-94B3-44BE299704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0520" y="437400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F1A9A-79AC-4ED6-BBB4-326A4B7AD7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0520" y="1768320"/>
            <a:ext cx="442584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694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725B4-1375-4936-AD7E-3DFFF14E93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6948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948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61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392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720" y="6886440"/>
            <a:ext cx="2346480" cy="519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6D22D6C8-BD41-4EC5-B315-A2E34829733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18253" r="24332" b="0"/>
          <a:stretch/>
        </p:blipFill>
        <p:spPr>
          <a:xfrm>
            <a:off x="5622840" y="2668680"/>
            <a:ext cx="3624480" cy="38098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18504" r="24137" b="0"/>
          <a:stretch/>
        </p:blipFill>
        <p:spPr>
          <a:xfrm>
            <a:off x="1514520" y="2827440"/>
            <a:ext cx="3524040" cy="36241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2976480" y="446040"/>
          <a:ext cx="4611600" cy="2154240"/>
        </p:xfrm>
        <a:graphic>
          <a:graphicData uri="http://schemas.openxmlformats.org/drawingml/2006/table">
            <a:tbl>
              <a:tblPr/>
              <a:tblGrid>
                <a:gridCol w="1278000"/>
                <a:gridCol w="1268280"/>
                <a:gridCol w="1349640"/>
                <a:gridCol w="715680"/>
              </a:tblGrid>
              <a:tr h="844560"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64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ow CD44v3 group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H score &lt; 5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gh CD44v3 grou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H score &gt;5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dian time to death in months (95%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64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 (15.5 – 82.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 (8.8 – 37.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5560"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dian time to progression in months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64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 (1.86 – 16.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 (2.5 – 5.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55800" bIns="46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28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-3960" y="0"/>
            <a:ext cx="2812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4245120" y="6716880"/>
            <a:ext cx="2048400" cy="484200"/>
            <a:chOff x="4245120" y="6716880"/>
            <a:chExt cx="2048400" cy="484200"/>
          </a:xfrm>
        </p:grpSpPr>
        <p:sp>
          <p:nvSpPr>
            <p:cNvPr id="46" name=""/>
            <p:cNvSpPr/>
            <p:nvPr/>
          </p:nvSpPr>
          <p:spPr>
            <a:xfrm>
              <a:off x="4245120" y="6875640"/>
              <a:ext cx="395280" cy="1440"/>
            </a:xfrm>
            <a:prstGeom prst="line">
              <a:avLst/>
            </a:prstGeom>
            <a:ln w="28440">
              <a:solidFill>
                <a:srgbClr val="c0504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245120" y="7113600"/>
              <a:ext cx="395280" cy="1440"/>
            </a:xfrm>
            <a:prstGeom prst="line">
              <a:avLst/>
            </a:prstGeom>
            <a:ln w="2844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754880" y="6954840"/>
              <a:ext cx="1538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High CD44v3 (&gt;media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753080" y="6716880"/>
              <a:ext cx="151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23960"/>
                  <a:tab algn="l" pos="144792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Low CD44v3 (&lt;media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6T15:07:34Z</dcterms:created>
  <dc:creator/>
  <dc:description/>
  <dc:language>en-US</dc:language>
  <cp:lastModifiedBy/>
  <cp:revision>1</cp:revision>
  <dc:subject/>
  <dc:title/>
</cp:coreProperties>
</file>